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32" r:id="rId1"/>
  </p:sldMasterIdLst>
  <p:notesMasterIdLst>
    <p:notesMasterId r:id="rId3"/>
  </p:notesMasterIdLst>
  <p:sldIdLst>
    <p:sldId id="302" r:id="rId2"/>
  </p:sldIdLst>
  <p:sldSz cx="7559675" cy="10439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37EFDE27-64D2-9A47-7EBA-F4D877437D86}" name="Crevel, Reinout van" initials="" userId="S::Reinout.vanCrevel@radboudumc.nl::c8a85eab-04e2-4374-80ac-ff56393b1662" providerId="AD"/>
  <p188:author id="{0A69D33C-A3AE-B2FD-DAE3-489C6085493B}" name="Setiabudiawan, Todia" initials="TS" userId="S::Todia.Setiabudiawan@radboudumc.nl::b66113ee-6b80-4b22-902e-4e4411cc18e9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7335"/>
    <p:restoredTop sz="94720"/>
  </p:normalViewPr>
  <p:slideViewPr>
    <p:cSldViewPr snapToGrid="0">
      <p:cViewPr varScale="1">
        <p:scale>
          <a:sx n="67" d="100"/>
          <a:sy n="67" d="100"/>
        </p:scale>
        <p:origin x="240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ED36B6E-0244-7342-9A93-7D998A0B8A7C}" type="datetimeFigureOut">
              <a:rPr lang="en-US" smtClean="0"/>
              <a:t>3/30/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11400" y="1143000"/>
            <a:ext cx="22352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A6B7A9C-8B5B-7A4D-836E-05FD47B04D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04364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08486"/>
            <a:ext cx="6425724" cy="3634458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483102"/>
            <a:ext cx="5669756" cy="2520438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80113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27770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55801"/>
            <a:ext cx="1630055" cy="8846909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55801"/>
            <a:ext cx="4795669" cy="8846909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88843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45521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02603"/>
            <a:ext cx="6520220" cy="4342500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6986185"/>
            <a:ext cx="6520220" cy="2283618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>
                    <a:tint val="82000"/>
                  </a:schemeClr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82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82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71163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779007"/>
            <a:ext cx="3212862" cy="662370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779007"/>
            <a:ext cx="3212862" cy="662370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37483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55804"/>
            <a:ext cx="6520220" cy="2017801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559104"/>
            <a:ext cx="3198096" cy="1254177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813281"/>
            <a:ext cx="3198096" cy="5608762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559104"/>
            <a:ext cx="3213847" cy="1254177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813281"/>
            <a:ext cx="3213847" cy="5608762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91291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45652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2888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95960"/>
            <a:ext cx="2438192" cy="2435860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03083"/>
            <a:ext cx="3827085" cy="7418740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131820"/>
            <a:ext cx="2438192" cy="5802084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22123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95960"/>
            <a:ext cx="2438192" cy="2435860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03083"/>
            <a:ext cx="3827085" cy="7418740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131820"/>
            <a:ext cx="2438192" cy="5802084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88030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55804"/>
            <a:ext cx="6520220" cy="201780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779007"/>
            <a:ext cx="6520220" cy="66237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675780"/>
            <a:ext cx="1700927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675780"/>
            <a:ext cx="2551390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675780"/>
            <a:ext cx="1700927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24421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3" r:id="rId1"/>
    <p:sldLayoutId id="2147483734" r:id="rId2"/>
    <p:sldLayoutId id="2147483735" r:id="rId3"/>
    <p:sldLayoutId id="2147483736" r:id="rId4"/>
    <p:sldLayoutId id="2147483737" r:id="rId5"/>
    <p:sldLayoutId id="2147483738" r:id="rId6"/>
    <p:sldLayoutId id="2147483739" r:id="rId7"/>
    <p:sldLayoutId id="2147483740" r:id="rId8"/>
    <p:sldLayoutId id="2147483741" r:id="rId9"/>
    <p:sldLayoutId id="2147483742" r:id="rId10"/>
    <p:sldLayoutId id="2147483743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Picture 22" descr="A table of samples&#10;&#10;Description automatically generated">
            <a:extLst>
              <a:ext uri="{FF2B5EF4-FFF2-40B4-BE49-F238E27FC236}">
                <a16:creationId xmlns:a16="http://schemas.microsoft.com/office/drawing/2014/main" id="{8330AA33-9D75-4221-997B-EB2E470E470A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66337" y="312248"/>
            <a:ext cx="6626999" cy="643736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E42F20EC-9258-F864-1554-17617B25EBB4}"/>
              </a:ext>
            </a:extLst>
          </p:cNvPr>
          <p:cNvSpPr txBox="1"/>
          <p:nvPr/>
        </p:nvSpPr>
        <p:spPr>
          <a:xfrm>
            <a:off x="204536" y="7021977"/>
            <a:ext cx="688879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2. Antibody panel for identification and sorting of murine lung cells</a:t>
            </a:r>
          </a:p>
        </p:txBody>
      </p:sp>
    </p:spTree>
    <p:extLst>
      <p:ext uri="{BB962C8B-B14F-4D97-AF65-F5344CB8AC3E}">
        <p14:creationId xmlns:p14="http://schemas.microsoft.com/office/powerpoint/2010/main" val="34603959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948</TotalTime>
  <Words>14</Words>
  <Application>Microsoft Macintosh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aomi Daniels</dc:creator>
  <cp:lastModifiedBy>Naomi Daniels</cp:lastModifiedBy>
  <cp:revision>5</cp:revision>
  <dcterms:created xsi:type="dcterms:W3CDTF">2025-04-08T03:28:33Z</dcterms:created>
  <dcterms:modified xsi:type="dcterms:W3CDTF">2026-03-30T03:33:21Z</dcterms:modified>
</cp:coreProperties>
</file>